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0A1B5D5-9B99-4C35-A422-299274C87663}" styleName="Estilo medio 1 - Énfasis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91"/>
    <p:restoredTop sz="94505"/>
  </p:normalViewPr>
  <p:slideViewPr>
    <p:cSldViewPr snapToGrid="0" snapToObjects="1">
      <p:cViewPr varScale="1">
        <p:scale>
          <a:sx n="108" d="100"/>
          <a:sy n="108" d="100"/>
        </p:scale>
        <p:origin x="208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FC5DF8-CF57-2448-BC27-B2C1D470DB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EB78F82-C84E-1146-9540-D4528F84CE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ACD6D3C-4372-494F-B8ED-F072172F4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397138-9C31-4244-A7F2-200C33350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492B52A-C06D-AB49-A40D-5C8D98B03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3971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BEAB05-F4D9-BF40-A2F3-4621130BDF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1CF335-9F93-934E-8D27-819883C045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47B630-29D5-A344-8CFB-4E042E74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8FBC0AB-2B5A-9145-90FD-97EEAF699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E645997-3816-6C40-A6A0-CF518F007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0829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09ADE95-753F-134B-8B68-71C1CAB1E8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727EF78-3C67-044E-B86B-8311ADB846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7CD8DBC-0B00-0049-B80D-F610A13E0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DD405CA-294F-5249-A727-926A98615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B4DE539-33B7-034B-9824-4EE16596F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6936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BF7202D-3907-0A4E-88D2-9220C7F750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E3E0704-8504-214D-AEB4-D2F92BD69D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15F310C-12BA-4C46-8401-119EA81B4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B876E7E-24B2-0243-ADD9-CBB802612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CAD084-FDDA-2441-ABA2-131CB494D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8526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8E91BF-A5E5-804B-BCD8-55BE9DD4E9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0F2700E-1167-784F-A108-B4BF8DC6D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34EEF59-F4E1-4041-A73F-E397E2747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85B040B-E7FD-9D4C-8BCE-8FD09181C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1D5C689-0119-3444-A9BC-D448254F4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4981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D41D7FC-F329-2042-870A-E0F0CB166A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CFCFDE8-5276-7241-A689-CD3498A4F7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C12A432-DFB7-0A43-ACC2-1F97B385AB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AFFA223-EA5A-AF4F-8259-2DEAFCC61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6C632CA-F9F2-FF44-8D1B-43A82C4C1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2C58A86-2691-2D4A-A215-443038FAA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6330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31A6F4-1C8A-C14F-814D-B95940E1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71F25E3-03C8-F445-AB35-39D5D54C3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0307DD3-E6E0-C643-931D-9521E61DA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C66EB152-B4F8-6247-A80E-1F26C0E8F2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0EEEE39-BA89-1043-82EC-EB464B8401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DD88C18-C745-A94E-ACD5-073B5A1BA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FBC04B5-3654-2443-AC67-6756C8238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337572E-A8D7-D24F-A5E7-13A28163F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1888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9CB5F7-CB04-C54E-9E8A-7C34E81794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707CE34-F11E-164A-B937-87E5311E0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CB198268-E0EC-C04D-8358-4C861E0BD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41AA20D-40A5-F549-BE0A-8941E90E3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3095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8A61277-5E2A-2E43-9A4E-A36CE4AA2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ED71163-34E2-884E-AA05-4F0654FCD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AD770C6-DD5C-DE4A-91B2-F2DB9A8BA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95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4F0C6E-F063-B641-86D2-7BF40E2DD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16EBF1B-00AA-8F41-BDDA-84B06CF968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2F1E248-E217-7D40-A550-3CCD63E3B3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4070639-8096-B24C-B8F3-D0E771926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440F696-CBFB-0349-AE0F-86C5D24AD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3940C3-DAA4-A24C-9CA0-A6E9F4461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247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79868F-2D1C-E44B-BF30-DA3398F40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CF95020-16A3-1148-B544-8A0E1D0A17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829FE25-7B90-2D49-B803-4210A8009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23DB674-BD7B-C748-8301-4BB3C856B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F266165-03F7-DB4B-BCDF-9300AA997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9F7B2B4-34F9-674B-87F8-E96BD23B7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065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31C2028-58FE-DC47-8016-BA3F807D9E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289D14C-1C48-384F-8AED-AB276CCD0E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096CE8C-45E2-6243-B057-85D8BF5B4C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0E916-18F8-6D42-9104-AFBE9149ED65}" type="datetimeFigureOut">
              <a:rPr lang="es-ES" smtClean="0"/>
              <a:t>1/9/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7259263-3A07-804F-8463-49507A8649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D5579FC-942D-CA42-9A8D-24AB77DA00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CC0D4-24D0-BE47-A06F-5D2A3EFDE76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5985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6BB5E6A-E880-C541-80AE-F80F4EF1AF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967948"/>
            <a:ext cx="9144000" cy="3231667"/>
          </a:xfrm>
        </p:spPr>
        <p:txBody>
          <a:bodyPr>
            <a:normAutofit fontScale="90000"/>
          </a:bodyPr>
          <a:lstStyle/>
          <a:p>
            <a:r>
              <a:rPr lang="es-ES" dirty="0"/>
              <a:t>Multimedia </a:t>
            </a:r>
            <a:r>
              <a:rPr lang="es-ES" dirty="0" err="1"/>
              <a:t>Appendix</a:t>
            </a:r>
            <a:r>
              <a:rPr lang="es-ES"/>
              <a:t> 1. </a:t>
            </a:r>
            <a:r>
              <a:rPr lang="es-ES" err="1"/>
              <a:t>Main</a:t>
            </a:r>
            <a:r>
              <a:rPr lang="es-ES"/>
              <a:t> </a:t>
            </a:r>
            <a:r>
              <a:rPr lang="es-ES" err="1"/>
              <a:t>themes</a:t>
            </a:r>
            <a:r>
              <a:rPr lang="es-ES"/>
              <a:t> of </a:t>
            </a:r>
            <a:r>
              <a:rPr lang="es-ES" err="1"/>
              <a:t>the</a:t>
            </a:r>
            <a:r>
              <a:rPr lang="es-ES"/>
              <a:t> APP </a:t>
            </a:r>
            <a:r>
              <a:rPr lang="es-ES" err="1"/>
              <a:t>message</a:t>
            </a:r>
            <a:r>
              <a:rPr lang="es-ES"/>
              <a:t> </a:t>
            </a:r>
            <a:r>
              <a:rPr lang="es-ES" err="1"/>
              <a:t>library</a:t>
            </a:r>
            <a:r>
              <a:rPr lang="es-ES"/>
              <a:t>. </a:t>
            </a:r>
            <a:br>
              <a:rPr lang="es-ES"/>
            </a:br>
            <a:endParaRPr lang="es-E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DB6360E-E69B-9545-AF1C-A91806466F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5845508"/>
            <a:ext cx="9144000" cy="831739"/>
          </a:xfrm>
        </p:spPr>
        <p:txBody>
          <a:bodyPr>
            <a:normAutofit fontScale="70000" lnSpcReduction="20000"/>
          </a:bodyPr>
          <a:lstStyle/>
          <a:p>
            <a:r>
              <a:rPr lang="en-US" sz="1600"/>
              <a:t>Effectiveness of PUSH notifications from a mobile app for improving the body composition of overweight or obese women: Randomized Controlled Trial.</a:t>
            </a:r>
          </a:p>
          <a:p>
            <a:endParaRPr lang="en-US" sz="1600"/>
          </a:p>
          <a:p>
            <a:r>
              <a:rPr lang="en-US" sz="1600"/>
              <a:t>Hernández-Reyes, A. </a:t>
            </a:r>
            <a:r>
              <a:rPr lang="en-US" sz="1600" i="1"/>
              <a:t>et al</a:t>
            </a:r>
            <a:r>
              <a:rPr lang="en-US" sz="1600"/>
              <a:t>. </a:t>
            </a:r>
            <a:r>
              <a:rPr lang="en-US" sz="1600" i="1"/>
              <a:t>2019</a:t>
            </a:r>
            <a:r>
              <a:rPr lang="en-US" sz="1600"/>
              <a:t>.</a:t>
            </a:r>
            <a:endParaRPr lang="es-ES" sz="1600"/>
          </a:p>
        </p:txBody>
      </p:sp>
    </p:spTree>
    <p:extLst>
      <p:ext uri="{BB962C8B-B14F-4D97-AF65-F5344CB8AC3E}">
        <p14:creationId xmlns:p14="http://schemas.microsoft.com/office/powerpoint/2010/main" val="3343622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BE2D7D41-2B20-7E4A-B77D-5BF6E7332D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0813661"/>
              </p:ext>
            </p:extLst>
          </p:nvPr>
        </p:nvGraphicFramePr>
        <p:xfrm>
          <a:off x="65256" y="49760"/>
          <a:ext cx="12095748" cy="672965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5958">
                  <a:extLst>
                    <a:ext uri="{9D8B030D-6E8A-4147-A177-3AD203B41FA5}">
                      <a16:colId xmlns:a16="http://schemas.microsoft.com/office/drawing/2014/main" val="3211400428"/>
                    </a:ext>
                  </a:extLst>
                </a:gridCol>
                <a:gridCol w="2015958">
                  <a:extLst>
                    <a:ext uri="{9D8B030D-6E8A-4147-A177-3AD203B41FA5}">
                      <a16:colId xmlns:a16="http://schemas.microsoft.com/office/drawing/2014/main" val="3433945590"/>
                    </a:ext>
                  </a:extLst>
                </a:gridCol>
                <a:gridCol w="2015958">
                  <a:extLst>
                    <a:ext uri="{9D8B030D-6E8A-4147-A177-3AD203B41FA5}">
                      <a16:colId xmlns:a16="http://schemas.microsoft.com/office/drawing/2014/main" val="1285522067"/>
                    </a:ext>
                  </a:extLst>
                </a:gridCol>
                <a:gridCol w="2015958">
                  <a:extLst>
                    <a:ext uri="{9D8B030D-6E8A-4147-A177-3AD203B41FA5}">
                      <a16:colId xmlns:a16="http://schemas.microsoft.com/office/drawing/2014/main" val="1916863242"/>
                    </a:ext>
                  </a:extLst>
                </a:gridCol>
                <a:gridCol w="2015958">
                  <a:extLst>
                    <a:ext uri="{9D8B030D-6E8A-4147-A177-3AD203B41FA5}">
                      <a16:colId xmlns:a16="http://schemas.microsoft.com/office/drawing/2014/main" val="3990210954"/>
                    </a:ext>
                  </a:extLst>
                </a:gridCol>
                <a:gridCol w="2015958">
                  <a:extLst>
                    <a:ext uri="{9D8B030D-6E8A-4147-A177-3AD203B41FA5}">
                      <a16:colId xmlns:a16="http://schemas.microsoft.com/office/drawing/2014/main" val="3259950131"/>
                    </a:ext>
                  </a:extLst>
                </a:gridCol>
              </a:tblGrid>
              <a:tr h="688839">
                <a:tc>
                  <a:txBody>
                    <a:bodyPr/>
                    <a:lstStyle/>
                    <a:p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nu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i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me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jective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SH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ificati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cuency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SH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8472244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r>
                        <a:rPr lang="es-E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inforcing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ehavior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tient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uragemen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e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crib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et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r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5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prise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0349712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xpressing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mpathy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llowed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y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nstructive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eedback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inforc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r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for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en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da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s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ginn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per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riday and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day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570501"/>
                  </a:ext>
                </a:extLst>
              </a:tr>
              <a:tr h="96778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festyle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ange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on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ink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snacks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fast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sert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nner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r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5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prise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508374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ponding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o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uestion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nd/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ormation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out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ssignment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bilit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on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efit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mb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ir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jumping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p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etc.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r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5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prise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744826"/>
                  </a:ext>
                </a:extLst>
              </a:tr>
              <a:tr h="114374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orking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ward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oal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ablishment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jectiv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hiev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crib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uragemen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hiev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inforcemen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r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er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5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for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to-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sultation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0430162"/>
                  </a:ext>
                </a:extLst>
              </a:tr>
              <a:tr h="615862">
                <a:tc>
                  <a:txBody>
                    <a:bodyPr/>
                    <a:lstStyle/>
                    <a:p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f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ontrol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struction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minder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to complete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online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ary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SH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ification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k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ter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PP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d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cat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y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al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ome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pris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ement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4803210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f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ontrol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sking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pdate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out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fe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nd general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eatment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100" kern="120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gress</a:t>
                      </a:r>
                      <a:r>
                        <a:rPr lang="es-ES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s-ES" sz="1100"/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SH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ification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quest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ormati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ements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a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k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icult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ow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cribed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et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,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prise</a:t>
                      </a:r>
                      <a:r>
                        <a:rPr lang="es-ES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ement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/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s-E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s-E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54063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43871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BE2D7D41-2B20-7E4A-B77D-5BF6E7332D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9143726"/>
              </p:ext>
            </p:extLst>
          </p:nvPr>
        </p:nvGraphicFramePr>
        <p:xfrm>
          <a:off x="65255" y="49760"/>
          <a:ext cx="11893197" cy="43153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17117">
                  <a:extLst>
                    <a:ext uri="{9D8B030D-6E8A-4147-A177-3AD203B41FA5}">
                      <a16:colId xmlns:a16="http://schemas.microsoft.com/office/drawing/2014/main" val="3211400428"/>
                    </a:ext>
                  </a:extLst>
                </a:gridCol>
                <a:gridCol w="8476080">
                  <a:extLst>
                    <a:ext uri="{9D8B030D-6E8A-4147-A177-3AD203B41FA5}">
                      <a16:colId xmlns:a16="http://schemas.microsoft.com/office/drawing/2014/main" val="1916863242"/>
                    </a:ext>
                  </a:extLst>
                </a:gridCol>
              </a:tblGrid>
              <a:tr h="688839">
                <a:tc>
                  <a:txBody>
                    <a:bodyPr/>
                    <a:lstStyle/>
                    <a:p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APP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enu</a:t>
                      </a:r>
                      <a:endParaRPr lang="es-ES" sz="1400" dirty="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essag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xample</a:t>
                      </a:r>
                      <a:endParaRPr lang="es-ES" sz="1400" dirty="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8472244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400" err="1">
                          <a:latin typeface="+mj-lt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40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err="1">
                          <a:latin typeface="+mj-lt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400">
                        <a:latin typeface="+mj-lt"/>
                        <a:cs typeface="Times New Roman" panose="02020603050405020304" pitchFamily="18" charset="0"/>
                      </a:endParaRPr>
                    </a:p>
                    <a:p>
                      <a:endParaRPr lang="es-ES" sz="140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 algn="l">
                        <a:buAutoNum type="romanLcParenR"/>
                      </a:pP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pp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eken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!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keep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resolution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can be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r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u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Nutrición Sur ca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elp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  <a:sym typeface="Wingdings" pitchFamily="2" charset="2"/>
                        </a:rPr>
                        <a:t></a:t>
                      </a:r>
                    </a:p>
                    <a:p>
                      <a:pPr marL="285750" indent="-285750" algn="l">
                        <a:buAutoNum type="romanLcParenR"/>
                      </a:pP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ek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gin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!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Remembe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e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consultatio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let'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go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goo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ek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!</a:t>
                      </a:r>
                    </a:p>
                    <a:p>
                      <a:pPr marL="285750" indent="-285750" algn="l">
                        <a:buAutoNum type="romanLcParenR"/>
                      </a:pP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dd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2 new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ealth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reakfas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recipe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njo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m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!</a:t>
                      </a:r>
                    </a:p>
                    <a:p>
                      <a:pPr marL="285750" indent="-285750" algn="l">
                        <a:buAutoNum type="romanLcParenR"/>
                      </a:pP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D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know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nefit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chia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eed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?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ell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pp!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570501"/>
                  </a:ext>
                </a:extLst>
              </a:tr>
              <a:tr h="791822">
                <a:tc>
                  <a:txBody>
                    <a:bodyPr/>
                    <a:lstStyle/>
                    <a:p>
                      <a:r>
                        <a:rPr lang="es-ES" sz="1400" err="1">
                          <a:latin typeface="+mj-lt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40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err="1">
                          <a:latin typeface="+mj-lt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40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err="1">
                          <a:latin typeface="+mj-lt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40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AutoNum type="romanLcParenR"/>
                        <a:tabLst/>
                        <a:defRPr/>
                      </a:pP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new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informatio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a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ad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jus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AutoNum type="romanLcParenR"/>
                        <a:tabLst/>
                        <a:defRPr/>
                      </a:pP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D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know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nefit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void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levato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climb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tair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?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xplai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i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you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pp!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744826"/>
                  </a:ext>
                </a:extLst>
              </a:tr>
              <a:tr h="615862">
                <a:tc>
                  <a:txBody>
                    <a:bodyPr/>
                    <a:lstStyle/>
                    <a:p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elf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-control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ips</a:t>
                      </a:r>
                      <a:endParaRPr lang="es-ES" sz="1400" dirty="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400" b="1" i="1" dirty="0" err="1">
                          <a:latin typeface="+mj-lt"/>
                          <a:cs typeface="Times New Roman" panose="02020603050405020304" pitchFamily="18" charset="0"/>
                        </a:rPr>
                        <a:t>Questio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Goo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orn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lea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indicat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ow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i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eken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has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e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relatio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 D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forg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updat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data in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elf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-control.</a:t>
                      </a:r>
                    </a:p>
                    <a:p>
                      <a:pPr algn="l"/>
                      <a:r>
                        <a:rPr lang="es-ES" sz="1400" b="1" dirty="0" err="1">
                          <a:latin typeface="+mj-lt"/>
                          <a:cs typeface="Times New Roman" panose="02020603050405020304" pitchFamily="18" charset="0"/>
                        </a:rPr>
                        <a:t>Possible</a:t>
                      </a:r>
                      <a:r>
                        <a:rPr lang="es-ES" sz="1400" b="1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b="1" dirty="0" err="1">
                          <a:latin typeface="+mj-lt"/>
                          <a:cs typeface="Times New Roman" panose="02020603050405020304" pitchFamily="18" charset="0"/>
                        </a:rPr>
                        <a:t>answer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: a) Yes,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compli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ropos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; b)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fulfill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u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NOT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xerci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; c)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e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bl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u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 d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xerci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; d)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e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bl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d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ithe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ie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o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exerci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4803210"/>
                  </a:ext>
                </a:extLst>
              </a:tr>
              <a:tr h="615862">
                <a:tc>
                  <a:txBody>
                    <a:bodyPr/>
                    <a:lstStyle/>
                    <a:p>
                      <a:endParaRPr lang="es-ES" sz="1400" dirty="0"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1400" b="1" i="1" dirty="0" err="1">
                          <a:latin typeface="+mj-lt"/>
                          <a:cs typeface="Times New Roman" panose="02020603050405020304" pitchFamily="18" charset="0"/>
                        </a:rPr>
                        <a:t>Questio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: "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Goo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orn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!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Remember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alk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10,000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tep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da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leas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elec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on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following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nswer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:</a:t>
                      </a:r>
                    </a:p>
                    <a:p>
                      <a:pPr algn="l"/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a)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Inde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y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verag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onth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i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in 10,000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teps</a:t>
                      </a:r>
                      <a:endParaRPr lang="es-ES" sz="1400" dirty="0">
                        <a:latin typeface="+mj-lt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b)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complicat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week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, I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hav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bee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bl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maintain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prescribed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average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400" dirty="0" err="1">
                          <a:latin typeface="+mj-lt"/>
                          <a:cs typeface="Times New Roman" panose="02020603050405020304" pitchFamily="18" charset="0"/>
                        </a:rPr>
                        <a:t>steps</a:t>
                      </a:r>
                      <a:r>
                        <a:rPr lang="es-ES" sz="1400" dirty="0">
                          <a:latin typeface="+mj-lt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5098523"/>
                  </a:ext>
                </a:extLst>
              </a:tr>
            </a:tbl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2C27A72C-FC28-E64B-AA0D-7CBAC4814237}"/>
              </a:ext>
            </a:extLst>
          </p:cNvPr>
          <p:cNvSpPr txBox="1"/>
          <p:nvPr/>
        </p:nvSpPr>
        <p:spPr>
          <a:xfrm>
            <a:off x="65255" y="4453247"/>
            <a:ext cx="118931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Note: To </a:t>
            </a:r>
            <a:r>
              <a:rPr lang="es-ES" sz="1400" dirty="0" err="1"/>
              <a:t>avoid</a:t>
            </a:r>
            <a:r>
              <a:rPr lang="es-ES" sz="1400" dirty="0"/>
              <a:t> </a:t>
            </a:r>
            <a:r>
              <a:rPr lang="es-ES" sz="1400" dirty="0" err="1"/>
              <a:t>falling</a:t>
            </a:r>
            <a:r>
              <a:rPr lang="es-ES" sz="1400" dirty="0"/>
              <a:t> </a:t>
            </a:r>
            <a:r>
              <a:rPr lang="es-ES" sz="1400" dirty="0" err="1"/>
              <a:t>into</a:t>
            </a:r>
            <a:r>
              <a:rPr lang="es-ES" sz="1400" dirty="0"/>
              <a:t> </a:t>
            </a:r>
            <a:r>
              <a:rPr lang="es-ES" sz="1400" dirty="0" err="1"/>
              <a:t>monotony</a:t>
            </a:r>
            <a:r>
              <a:rPr lang="es-ES" sz="1400" dirty="0"/>
              <a:t>,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messages</a:t>
            </a:r>
            <a:r>
              <a:rPr lang="es-ES" sz="1400" dirty="0"/>
              <a:t> are </a:t>
            </a:r>
            <a:r>
              <a:rPr lang="es-ES" sz="1400" dirty="0" err="1"/>
              <a:t>changed</a:t>
            </a:r>
            <a:r>
              <a:rPr lang="es-ES" sz="1400" dirty="0"/>
              <a:t> and </a:t>
            </a:r>
            <a:r>
              <a:rPr lang="es-ES" sz="1400" dirty="0" err="1"/>
              <a:t>updated</a:t>
            </a:r>
            <a:r>
              <a:rPr lang="es-ES" sz="1400" dirty="0"/>
              <a:t> </a:t>
            </a:r>
            <a:r>
              <a:rPr lang="es-ES" sz="1400" dirty="0" err="1"/>
              <a:t>every</a:t>
            </a:r>
            <a:r>
              <a:rPr lang="es-ES" sz="1400" dirty="0"/>
              <a:t> </a:t>
            </a:r>
            <a:r>
              <a:rPr lang="es-ES" sz="1400" dirty="0" err="1"/>
              <a:t>month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28904111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3</TotalTime>
  <Words>600</Words>
  <Application>Microsoft Macintosh PowerPoint</Application>
  <PresentationFormat>Panorámica</PresentationFormat>
  <Paragraphs>69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Wingdings</vt:lpstr>
      <vt:lpstr>Tema de Office</vt:lpstr>
      <vt:lpstr>Multimedia Appendix 1. Main themes of the APP message library.  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1. Main themes of the APP message library  </dc:title>
  <dc:creator>Alberto Hdez</dc:creator>
  <cp:lastModifiedBy>Alberto Hdez</cp:lastModifiedBy>
  <cp:revision>14</cp:revision>
  <dcterms:created xsi:type="dcterms:W3CDTF">2019-05-03T09:03:56Z</dcterms:created>
  <dcterms:modified xsi:type="dcterms:W3CDTF">2019-09-01T18:29:16Z</dcterms:modified>
</cp:coreProperties>
</file>